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8F30"/>
    <a:srgbClr val="CC0000"/>
    <a:srgbClr val="FF0000"/>
    <a:srgbClr val="CC3300"/>
    <a:srgbClr val="2D84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452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E3AE6-449F-416B-B469-2B5BAB1853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C81D4B-518D-4D81-8FCC-BA4B376C78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8A001-CAF3-4FAB-BC40-1B560C6CF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BC3C2-2331-4A48-AEE7-479F948CF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E6A121-7A2E-4395-BB86-A5424AA4D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010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1D250B-D3B9-49CA-BBEF-609880AFD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95BEA9-826F-4AB7-9976-00087B240B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BD2B29-BEFD-4703-9DDB-FE3CC430E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8461D-3382-440A-A469-6CCF3B4EC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8C413C-7701-4B43-AC58-6FF72889D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816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94DF4F-6B40-4C00-A8E4-FD124B580E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C7DF48-9280-420E-A5AD-35A7CA8B71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35E73-128D-4580-B8A1-F617D9949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37DB2-3971-4CDC-AC02-FAD694760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06C782-9C3F-4C1F-901E-FCB701802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437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8BBFC-F68D-46A8-990E-FF8BDAFED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5CDD7C-C26A-441D-9114-70E48B298D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B0A3C2-7FB0-41BC-AE6A-A392794E4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CBE6A-0830-477C-B2E0-A9BFED233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EDF2B-4D1A-4C90-88A4-66A9CF1B8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297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058B8-B930-4EA7-A44D-A18DDF7E5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3CEF61-4EF0-483A-AB8B-59A5EC3A6F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29752C-E55F-4937-9F7A-B6F265E11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8150E1-8A8E-4D4B-BBF2-586701117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1C65B7-9629-4DDE-8928-0C3C4BFDF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560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90475-770D-4870-AF01-944B975FD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34FC42-7AD2-4D5C-AB78-57A760B537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398A89-97DD-4A57-962D-D302AD71DB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70EDF1-99A6-4264-BB77-4036FA16A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40CAA8-9C1A-4391-A200-7CD88E885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DBB6C8-FB3A-4770-8597-37E86B4A2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328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D9E84-6CEF-4FC6-B579-D3C85D858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7D09A0-E58E-4F50-B379-00D9976047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C756D2-612E-45A3-892E-18E2A89767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A80C95-68F7-4556-8217-29A175C471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4BDC39-7575-4E70-8905-9930AB56FD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36DB48-9E0A-4D88-88F7-FFCD54BF3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C1565B-8689-433B-9C81-ACE8F4A12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968DD0-0C15-4F58-80CB-30085E806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262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4E8619-E5FE-49AA-977F-D837DE2D7B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EE4EB4-C2E3-4898-8B91-65880BBDA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2ECB3B-AA76-4EBD-A980-9B0FA3E1B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AF8C95-45EC-4018-8E08-48384B361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488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844FF5-F160-4D05-B50B-50DC9E34F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6406BD-22FB-4EEB-AD8F-339090F5D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907281-ABE8-4C02-9C23-28840FD31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946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B704E-2D47-4780-88A5-5C287F9EEE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24180D-BBBB-4D37-9F89-8E15017AD7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84A131-A75D-41AB-B320-D7C25DC36B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CB7E5D-DB86-46F6-B34E-1D210D376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9545E2-581E-4A4E-A799-2F47F2789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BA9D03-7965-449D-94E4-C62428A6A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778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E7AC0-71BB-43F7-BD0E-E7E65D4DF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7F0720-202F-491C-BE23-D64A47DD6D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18B5BD-F903-4357-8D23-84CCD0066F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E49BEA-4723-4403-B62E-95C1DE934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DBFCD8-F592-4ADF-86D6-A419E0241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127917-AC18-42BE-A4D5-2272161D7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823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7A2A78-64BD-4DCF-A44E-55CA8EB0FF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C3C200-0945-4601-89F1-EA995F4FE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C073DC-9295-4E37-ACF8-8CC61BF69D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3F021-54DB-422C-BAE8-6A54E230539B}" type="datetimeFigureOut">
              <a:rPr lang="en-US" smtClean="0"/>
              <a:t>2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75933-FE36-4E99-8185-FD81C17B8C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153B23-AE32-422B-8333-C2238EC921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83EB1-3D0D-4879-981B-A3BD873CEC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595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>
            <a:extLst>
              <a:ext uri="{FF2B5EF4-FFF2-40B4-BE49-F238E27FC236}">
                <a16:creationId xmlns:a16="http://schemas.microsoft.com/office/drawing/2014/main" id="{AF08BD7E-00BC-4D2F-92C8-EC336F70CC47}"/>
              </a:ext>
            </a:extLst>
          </p:cNvPr>
          <p:cNvSpPr/>
          <p:nvPr/>
        </p:nvSpPr>
        <p:spPr>
          <a:xfrm>
            <a:off x="549835" y="179293"/>
            <a:ext cx="11361271" cy="560539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rgbClr val="CC33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NTRAL ILLUSTRATION: </a:t>
            </a:r>
            <a:r>
              <a:rPr lang="en-US" sz="16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Tc</a:t>
            </a:r>
            <a:r>
              <a:rPr lang="en-US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ynamics Following Cardioversion for Persistent Atrial Fibrillation</a:t>
            </a:r>
            <a:endParaRPr 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32267" y="1479670"/>
            <a:ext cx="11748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istent Atrial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Fibrillation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2"/>
          <a:srcRect r="37537"/>
          <a:stretch/>
        </p:blipFill>
        <p:spPr>
          <a:xfrm>
            <a:off x="1612664" y="1463039"/>
            <a:ext cx="1770616" cy="490450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5095" y="2695991"/>
            <a:ext cx="1315911" cy="770415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522324" y="2877247"/>
            <a:ext cx="10583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overs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97870" y="4114806"/>
            <a:ext cx="10583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Hours Post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oversion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36017" y="5461466"/>
            <a:ext cx="10583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 Hours Post</a:t>
            </a:r>
          </a:p>
          <a:p>
            <a:r>
              <a:rPr lang="en-US" sz="1200" dirty="0">
                <a:solidFill>
                  <a:schemeClr val="accent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dioversion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1002542" y="1941335"/>
            <a:ext cx="0" cy="635610"/>
          </a:xfrm>
          <a:prstGeom prst="straightConnector1">
            <a:avLst/>
          </a:prstGeom>
          <a:ln w="57150">
            <a:tailEnd type="triangle"/>
          </a:ln>
          <a:effectLst>
            <a:outerShdw blurRad="50800" dist="38100" dir="10800000" algn="r" rotWithShape="0">
              <a:prstClr val="black">
                <a:alpha val="40000"/>
              </a:prstClr>
            </a:outerShdw>
            <a:reflection blurRad="6350" stA="52000" endA="300" endPos="35000" dir="5400000" sy="-100000" algn="bl" rotWithShape="0"/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989211" y="4704528"/>
            <a:ext cx="0" cy="640080"/>
          </a:xfrm>
          <a:prstGeom prst="straightConnector1">
            <a:avLst/>
          </a:prstGeom>
          <a:ln w="57150">
            <a:solidFill>
              <a:schemeClr val="accent2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275126" y="1096509"/>
            <a:ext cx="1284408" cy="307777"/>
          </a:xfrm>
          <a:prstGeom prst="rect">
            <a:avLst/>
          </a:prstGeom>
          <a:gradFill flip="none" rotWithShape="1">
            <a:gsLst>
              <a:gs pos="0">
                <a:schemeClr val="accent1">
                  <a:lumMod val="67000"/>
                </a:schemeClr>
              </a:gs>
              <a:gs pos="48000">
                <a:schemeClr val="accent1">
                  <a:lumMod val="97000"/>
                  <a:lumOff val="3000"/>
                </a:schemeClr>
              </a:gs>
              <a:gs pos="100000">
                <a:schemeClr val="accent1">
                  <a:lumMod val="60000"/>
                  <a:lumOff val="40000"/>
                </a:schemeClr>
              </a:gs>
            </a:gsLst>
            <a:lin ang="16200000" scaled="1"/>
            <a:tileRect/>
          </a:gradFill>
          <a:ln>
            <a:noFill/>
          </a:ln>
          <a:effectLst>
            <a:outerShdw blurRad="50800" dist="38100" dir="13500000" algn="br" rotWithShape="0">
              <a:prstClr val="black">
                <a:alpha val="40000"/>
              </a:prstClr>
            </a:outerShdw>
            <a:softEdge rad="31750"/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Tc Interval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567859" y="1760963"/>
            <a:ext cx="655949" cy="276999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50800" dist="38100" dir="13500000" algn="br" rotWithShape="0">
              <a:prstClr val="black">
                <a:alpha val="40000"/>
              </a:prstClr>
            </a:outerShdw>
            <a:softEdge rad="31750"/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508404" y="5738465"/>
            <a:ext cx="817852" cy="276999"/>
          </a:xfrm>
          <a:prstGeom prst="rect">
            <a:avLst/>
          </a:prstGeom>
          <a:solidFill>
            <a:schemeClr val="accent2"/>
          </a:solidFill>
          <a:ln>
            <a:noFill/>
          </a:ln>
          <a:effectLst>
            <a:outerShdw blurRad="50800" dist="38100" dir="13500000" algn="br" rotWithShape="0">
              <a:prstClr val="black">
                <a:alpha val="40000"/>
              </a:prstClr>
            </a:outerShdw>
            <a:softEdge rad="31750"/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longed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567859" y="4157357"/>
            <a:ext cx="655949" cy="276999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50800" dist="38100" dir="13500000" algn="br" rotWithShape="0">
              <a:prstClr val="black">
                <a:alpha val="40000"/>
              </a:prstClr>
            </a:outerShdw>
            <a:softEdge rad="31750"/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none" rtlCol="0" anchor="ctr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989211" y="3344009"/>
            <a:ext cx="0" cy="640080"/>
          </a:xfrm>
          <a:prstGeom prst="straightConnector1">
            <a:avLst/>
          </a:prstGeom>
          <a:ln w="57150">
            <a:tailEnd type="triangle"/>
          </a:ln>
          <a:effectLst>
            <a:outerShdw blurRad="50800" dist="38100" dir="10800000" algn="r" rotWithShape="0">
              <a:prstClr val="black">
                <a:alpha val="40000"/>
              </a:prstClr>
            </a:outerShdw>
            <a:reflection blurRad="6350" stA="52000" endA="300" endPos="35000" dir="5400000" sy="-100000" algn="bl" rotWithShape="0"/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9534" y="1673313"/>
            <a:ext cx="7351572" cy="4571381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5552903" y="1299298"/>
            <a:ext cx="5822864" cy="73866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ily/Conventional (columns) and Cumulative (line) Detection Rates of Potentially Dangerous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Tc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longation Following Cardioversion during 7 days of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lter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nitoring.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3094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</TotalTime>
  <Words>5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nis, Arwa</dc:creator>
  <cp:lastModifiedBy>Bodurian, Christopher</cp:lastModifiedBy>
  <cp:revision>37</cp:revision>
  <dcterms:created xsi:type="dcterms:W3CDTF">2019-10-29T00:05:07Z</dcterms:created>
  <dcterms:modified xsi:type="dcterms:W3CDTF">2022-02-21T14:25:52Z</dcterms:modified>
</cp:coreProperties>
</file>